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8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C6DC2A-FB4D-404A-AC08-95905D8EFF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9428CC-33AE-4837-9AE3-1239217592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B97DF-405B-4300-B155-341E78393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EB74BB-A2F2-4841-89A3-CD2DFBD7F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F4AAC6-A389-4114-B6AD-AB9A381E9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9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A40DDA-74CC-4D3A-A2D1-EF29E07E3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04A5B0-1941-41FA-9612-3E4BD7D9FB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937DBA-3D33-4F54-ACDF-6EB97EBCB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85423-F4C4-488F-848F-6F40C45E7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C71014-0F35-4190-9705-E45D46ADC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776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3C5840-2E0F-46D8-B8C6-4608A3BEAA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D0D694-1FC2-4D27-9B63-5D18C1EC2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AE4EA6-54BA-47A7-A317-23EC03AD9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1D0E-BE58-4C1C-AEDD-23969E43C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979EA2-49A6-458E-BA84-25BF1369B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43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2A489-6D1B-4D23-AEA1-F4FA5D83A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B9056B-74AD-4042-8768-08AEEFA6FF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ABC12F-BAD6-426B-BEA4-28EE527B5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6545F8-3105-4E3A-8A5F-20D8B8332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E226F0-5DA5-443C-9FF5-192D4D036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878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BF7A3-3ADD-4B51-9508-9EE5F1BD1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B5EFC5-498F-4F27-92F7-B896BEF2D2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0F45DF-2A6C-408C-B928-36F1129B5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56CBFF-C498-4DCA-8AEC-55CD9F05A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E32E94-0E69-44EA-AD81-A5F6C5A54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106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5B450-8C5C-446A-8C3F-F24ED26BD2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E1D08-67EA-447D-B398-66EAF94C52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EBD156-BD36-4176-8610-167D81BA8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4F6024-7533-4188-A470-854745B24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4EDFCF-FACB-4886-A1EC-755096244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61C51F-0154-4C8D-8D61-53FE6B2B6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071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C7374-684C-4EC3-AB55-D160B9DD7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974D42-5687-4916-982B-52ED599DB8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71B277-9BB7-45BD-A126-D63A96AC0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126D25-321B-400D-A403-3BFA162FC1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9F4974-76DD-4CD1-97D9-050728C2C0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BE8DE5-91F6-487F-B100-10635744F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DC50BB-C354-4983-B2F3-29DEC2214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EE6DC6-D68A-4044-9871-249DE6F8C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87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4E9C0-2A23-45CC-9ADC-FFF687020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0CF039-6B24-4801-9675-A6EAA5154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3C95EB-4DB4-4230-B190-B46A53B48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6B70D0-EAD6-4D8D-BF64-0595BA2D5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471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5C9EE8-A214-4A24-8398-0DCBD77AC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70D72C-A29F-49C1-9CE1-B06AF4507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45072E-8AA5-4B6F-9AC9-1649AABA9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635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76992-50F4-41AE-9903-EDDBC9CB7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28B5A2-6AE2-4D44-A034-01289914D6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F5BC50-7640-426C-9921-CD7FD9A5D7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43449F-B3F7-47CA-B1E1-42FA998CB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1525D8-CBF0-4B50-A0E7-CAB22193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AA9EFA-0FBD-4A0B-8245-D71995AA5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181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EC6A7-DB3E-404F-AAAF-37B39666F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54BA79-C3E6-4367-ACFA-9ABE8D1C1A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72E485-9EE4-42BF-8604-54C23417FD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84B7F2-D8DE-41C6-A791-4F52B67EB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A62D69-EFBB-427C-A0C3-80F466E90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046C5F-E7D0-45FB-934C-111076591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85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9645ED-FB4B-4BBC-A941-22E73A03B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7126D5-F276-41E1-99F5-C0FEA99005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E6C4C-8F15-4676-A117-1E85B33D48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BE7B7-8341-4988-B70C-6CFE8897FBDA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18CDB7-2D17-4EA9-89CE-8697F3F053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63DBCF-5B51-497E-A578-24E2BF55F4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FF7C9-D03D-4D34-9EA3-609C704DF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060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AF5AC79-135B-4A0B-831D-F079518E207A}"/>
              </a:ext>
            </a:extLst>
          </p:cNvPr>
          <p:cNvSpPr txBox="1"/>
          <p:nvPr/>
        </p:nvSpPr>
        <p:spPr>
          <a:xfrm>
            <a:off x="199387" y="-98188"/>
            <a:ext cx="25637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l Figure 4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D8C87AA-B681-4F8E-8CB0-A2CA6CA49D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3153434"/>
              </p:ext>
            </p:extLst>
          </p:nvPr>
        </p:nvGraphicFramePr>
        <p:xfrm>
          <a:off x="625475" y="487363"/>
          <a:ext cx="3367088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9" r:id="rId3" imgW="3860295" imgH="2680911" progId="Prism9.Document">
                  <p:embed/>
                </p:oleObj>
              </mc:Choice>
              <mc:Fallback>
                <p:oleObj name="Prism 9" r:id="rId3" imgW="3860295" imgH="2680911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D8C87AA-B681-4F8E-8CB0-A2CA6CA49D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5475" y="487363"/>
                        <a:ext cx="3367088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4E53DD0-62D1-4289-B12A-09114BBF15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0738892"/>
              </p:ext>
            </p:extLst>
          </p:nvPr>
        </p:nvGraphicFramePr>
        <p:xfrm>
          <a:off x="4154488" y="485775"/>
          <a:ext cx="3341687" cy="2343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9" r:id="rId5" imgW="3869298" imgH="2712955" progId="Prism9.Document">
                  <p:embed/>
                </p:oleObj>
              </mc:Choice>
              <mc:Fallback>
                <p:oleObj name="Prism 9" r:id="rId5" imgW="3869298" imgH="271295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4E53DD0-62D1-4289-B12A-09114BBF15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54488" y="485775"/>
                        <a:ext cx="3341687" cy="2343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A2A145A-46A7-45C9-A4B6-DDD7FB481E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3407088"/>
              </p:ext>
            </p:extLst>
          </p:nvPr>
        </p:nvGraphicFramePr>
        <p:xfrm>
          <a:off x="7661275" y="485775"/>
          <a:ext cx="3276600" cy="2343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9" r:id="rId7" imgW="3793309" imgH="2712955" progId="Prism9.Document">
                  <p:embed/>
                </p:oleObj>
              </mc:Choice>
              <mc:Fallback>
                <p:oleObj name="Prism 9" r:id="rId7" imgW="3793309" imgH="271295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A2A145A-46A7-45C9-A4B6-DDD7FB481E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661275" y="485775"/>
                        <a:ext cx="3276600" cy="2343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BA87A5A-186B-4DA9-A86B-8D1ABF93DA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332305"/>
              </p:ext>
            </p:extLst>
          </p:nvPr>
        </p:nvGraphicFramePr>
        <p:xfrm>
          <a:off x="1778000" y="3354388"/>
          <a:ext cx="3098800" cy="2368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9" r:id="rId9" imgW="3841928" imgH="2937265" progId="Prism9.Document">
                  <p:embed/>
                </p:oleObj>
              </mc:Choice>
              <mc:Fallback>
                <p:oleObj name="Prism 9" r:id="rId9" imgW="3841928" imgH="2937265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5BA87A5A-186B-4DA9-A86B-8D1ABF93DA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78000" y="3354388"/>
                        <a:ext cx="3098800" cy="2368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Group 15">
            <a:extLst>
              <a:ext uri="{FF2B5EF4-FFF2-40B4-BE49-F238E27FC236}">
                <a16:creationId xmlns:a16="http://schemas.microsoft.com/office/drawing/2014/main" id="{28E50348-7CD6-4737-80FA-DFD9B3650A56}"/>
              </a:ext>
            </a:extLst>
          </p:cNvPr>
          <p:cNvGrpSpPr/>
          <p:nvPr/>
        </p:nvGrpSpPr>
        <p:grpSpPr>
          <a:xfrm>
            <a:off x="2356333" y="2828474"/>
            <a:ext cx="971732" cy="369332"/>
            <a:chOff x="1151792" y="3518178"/>
            <a:chExt cx="971732" cy="369332"/>
          </a:xfrm>
        </p:grpSpPr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96B2AFDA-A7DB-44F0-8777-31F0D6C7353F}"/>
                </a:ext>
              </a:extLst>
            </p:cNvPr>
            <p:cNvSpPr/>
            <p:nvPr/>
          </p:nvSpPr>
          <p:spPr>
            <a:xfrm>
              <a:off x="1151792" y="3630490"/>
              <a:ext cx="137160" cy="137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63171B2-44D2-4792-A1A5-4C6A2A62C011}"/>
                </a:ext>
              </a:extLst>
            </p:cNvPr>
            <p:cNvSpPr txBox="1"/>
            <p:nvPr/>
          </p:nvSpPr>
          <p:spPr>
            <a:xfrm>
              <a:off x="1305840" y="3518178"/>
              <a:ext cx="8176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aline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2A168AC-ABD4-4D6F-8109-2FDE39196592}"/>
              </a:ext>
            </a:extLst>
          </p:cNvPr>
          <p:cNvGrpSpPr/>
          <p:nvPr/>
        </p:nvGrpSpPr>
        <p:grpSpPr>
          <a:xfrm>
            <a:off x="3736723" y="2828474"/>
            <a:ext cx="974302" cy="369332"/>
            <a:chOff x="2461846" y="3527702"/>
            <a:chExt cx="974302" cy="369332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4A0860EF-2E1A-42FC-B722-CBC331DDE496}"/>
                </a:ext>
              </a:extLst>
            </p:cNvPr>
            <p:cNvSpPr/>
            <p:nvPr/>
          </p:nvSpPr>
          <p:spPr>
            <a:xfrm>
              <a:off x="2461846" y="3648074"/>
              <a:ext cx="137160" cy="13716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9514A88-D3AF-473B-978C-53DE5F5257A2}"/>
                </a:ext>
              </a:extLst>
            </p:cNvPr>
            <p:cNvSpPr txBox="1"/>
            <p:nvPr/>
          </p:nvSpPr>
          <p:spPr>
            <a:xfrm>
              <a:off x="2618464" y="3527702"/>
              <a:ext cx="8176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IL-1</a:t>
              </a:r>
              <a:r>
                <a:rPr lang="el-GR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US" dirty="0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BC7EF12-6F9E-41BA-B736-B2DFC10C8975}"/>
              </a:ext>
            </a:extLst>
          </p:cNvPr>
          <p:cNvGrpSpPr/>
          <p:nvPr/>
        </p:nvGrpSpPr>
        <p:grpSpPr>
          <a:xfrm>
            <a:off x="5061620" y="2828474"/>
            <a:ext cx="1734832" cy="369332"/>
            <a:chOff x="3892247" y="3464021"/>
            <a:chExt cx="1734832" cy="369332"/>
          </a:xfrm>
        </p:grpSpPr>
        <p:sp>
          <p:nvSpPr>
            <p:cNvPr id="12" name="Isosceles Triangle 11">
              <a:extLst>
                <a:ext uri="{FF2B5EF4-FFF2-40B4-BE49-F238E27FC236}">
                  <a16:creationId xmlns:a16="http://schemas.microsoft.com/office/drawing/2014/main" id="{52EC4FCC-6DA9-4241-B674-7346694D81DB}"/>
                </a:ext>
              </a:extLst>
            </p:cNvPr>
            <p:cNvSpPr/>
            <p:nvPr/>
          </p:nvSpPr>
          <p:spPr>
            <a:xfrm>
              <a:off x="3892247" y="3583127"/>
              <a:ext cx="137160" cy="137160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4F93F2A-1184-4133-A493-80110584D16E}"/>
                </a:ext>
              </a:extLst>
            </p:cNvPr>
            <p:cNvSpPr txBox="1"/>
            <p:nvPr/>
          </p:nvSpPr>
          <p:spPr>
            <a:xfrm>
              <a:off x="4027585" y="3464021"/>
              <a:ext cx="15994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PH: SA_ IL-1</a:t>
              </a:r>
              <a:r>
                <a:rPr lang="el-GR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endParaRPr lang="en-US" dirty="0"/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DF339C0-9C7D-4545-84E8-1B92811A6282}"/>
              </a:ext>
            </a:extLst>
          </p:cNvPr>
          <p:cNvGrpSpPr/>
          <p:nvPr/>
        </p:nvGrpSpPr>
        <p:grpSpPr>
          <a:xfrm>
            <a:off x="7149865" y="2828474"/>
            <a:ext cx="1762606" cy="369332"/>
            <a:chOff x="6050828" y="3472664"/>
            <a:chExt cx="1762606" cy="369332"/>
          </a:xfrm>
        </p:grpSpPr>
        <p:sp>
          <p:nvSpPr>
            <p:cNvPr id="14" name="Isosceles Triangle 13">
              <a:extLst>
                <a:ext uri="{FF2B5EF4-FFF2-40B4-BE49-F238E27FC236}">
                  <a16:creationId xmlns:a16="http://schemas.microsoft.com/office/drawing/2014/main" id="{5BC48ACF-B126-49CC-9FC4-8D8EE46B4044}"/>
                </a:ext>
              </a:extLst>
            </p:cNvPr>
            <p:cNvSpPr/>
            <p:nvPr/>
          </p:nvSpPr>
          <p:spPr>
            <a:xfrm rot="10800000">
              <a:off x="6050828" y="3601271"/>
              <a:ext cx="137160" cy="137160"/>
            </a:xfrm>
            <a:prstGeom prst="triangle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71C0C3D-98DD-48FF-A547-816F8AF0FF01}"/>
                </a:ext>
              </a:extLst>
            </p:cNvPr>
            <p:cNvSpPr txBox="1"/>
            <p:nvPr/>
          </p:nvSpPr>
          <p:spPr>
            <a:xfrm>
              <a:off x="6213940" y="3472664"/>
              <a:ext cx="15994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lank_ CPH: SA</a:t>
              </a:r>
            </a:p>
          </p:txBody>
        </p:sp>
      </p:grp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4CDEC9FC-8D72-47A1-9AE1-E7F673BDD8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3338874"/>
              </p:ext>
            </p:extLst>
          </p:nvPr>
        </p:nvGraphicFramePr>
        <p:xfrm>
          <a:off x="5340350" y="3411538"/>
          <a:ext cx="3236913" cy="2357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9" r:id="rId11" imgW="3839047" imgH="2793966" progId="Prism9.Document">
                  <p:embed/>
                </p:oleObj>
              </mc:Choice>
              <mc:Fallback>
                <p:oleObj name="Prism 9" r:id="rId11" imgW="3839047" imgH="2793966" progId="Prism9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4CDEC9FC-8D72-47A1-9AE1-E7F673BDD8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40350" y="3411538"/>
                        <a:ext cx="3236913" cy="2357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4951D561-A1D9-4FF4-95E2-4CA2C292E2C7}"/>
              </a:ext>
            </a:extLst>
          </p:cNvPr>
          <p:cNvSpPr txBox="1"/>
          <p:nvPr/>
        </p:nvSpPr>
        <p:spPr>
          <a:xfrm>
            <a:off x="207327" y="5770310"/>
            <a:ext cx="107798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emental Figure 4</a:t>
            </a:r>
            <a:r>
              <a:rPr lang="en-US" sz="1400" dirty="0"/>
              <a:t>: </a:t>
            </a:r>
            <a:r>
              <a:rPr lang="en-US" sz="1400" b="1" dirty="0"/>
              <a:t>Serum biomarkers of liver and kidney toxicity. </a:t>
            </a:r>
            <a:r>
              <a:rPr lang="en-US" sz="1400" dirty="0"/>
              <a:t>(</a:t>
            </a:r>
            <a:r>
              <a:rPr lang="en-US" sz="1400" b="1" dirty="0"/>
              <a:t>A-E</a:t>
            </a:r>
            <a:r>
              <a:rPr lang="en-US" sz="1400" dirty="0"/>
              <a:t>) mEERL tumor-bearing C57Bl/6 mice (n=3–4/treatment group) were treated with saline as a control, rIL-1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1400" dirty="0"/>
              <a:t>, CPH:SA_IL-1</a:t>
            </a:r>
            <a:r>
              <a:rPr lang="el-GR" sz="14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1400" dirty="0"/>
              <a:t>MPs, and empty particles at a dose described in figure 3. Blood was collected from the experimental animals and serum level of </a:t>
            </a:r>
            <a:r>
              <a:rPr lang="en-US" sz="1400" b="1" dirty="0"/>
              <a:t>A</a:t>
            </a:r>
            <a:r>
              <a:rPr lang="en-US" sz="1400" dirty="0"/>
              <a:t>) Alkaline phosphatase (ALP), </a:t>
            </a:r>
            <a:r>
              <a:rPr lang="en-US" sz="1400" b="1" dirty="0"/>
              <a:t>B</a:t>
            </a:r>
            <a:r>
              <a:rPr lang="en-US" sz="1400" dirty="0"/>
              <a:t>) Aspartate aminotransferase (AST), </a:t>
            </a:r>
            <a:r>
              <a:rPr lang="en-US" sz="1400" b="1" dirty="0"/>
              <a:t>C</a:t>
            </a:r>
            <a:r>
              <a:rPr lang="en-US" sz="1400" dirty="0"/>
              <a:t>) Alanine aminotransferase (ALT), </a:t>
            </a:r>
            <a:r>
              <a:rPr lang="en-US" sz="1400" b="1" dirty="0"/>
              <a:t>D</a:t>
            </a:r>
            <a:r>
              <a:rPr lang="en-US" sz="1400" dirty="0"/>
              <a:t>) Total bilirubin TBIL and </a:t>
            </a:r>
            <a:r>
              <a:rPr lang="en-US" sz="1400" b="1" dirty="0"/>
              <a:t>E</a:t>
            </a:r>
            <a:r>
              <a:rPr lang="en-US" sz="1400" dirty="0"/>
              <a:t>) creatine level was measured. The dotted line indicates normal reference value of C57Bl/6 mice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320713-152A-4006-993D-5914A1114BE8}"/>
              </a:ext>
            </a:extLst>
          </p:cNvPr>
          <p:cNvSpPr txBox="1"/>
          <p:nvPr/>
        </p:nvSpPr>
        <p:spPr>
          <a:xfrm>
            <a:off x="688055" y="264012"/>
            <a:ext cx="2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F47121-3FB4-4E10-B3DC-0C3712DECDFF}"/>
              </a:ext>
            </a:extLst>
          </p:cNvPr>
          <p:cNvSpPr txBox="1"/>
          <p:nvPr/>
        </p:nvSpPr>
        <p:spPr>
          <a:xfrm>
            <a:off x="4246479" y="268342"/>
            <a:ext cx="2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3194C4-522F-4226-B035-FD7891A19442}"/>
              </a:ext>
            </a:extLst>
          </p:cNvPr>
          <p:cNvSpPr txBox="1"/>
          <p:nvPr/>
        </p:nvSpPr>
        <p:spPr>
          <a:xfrm>
            <a:off x="7694862" y="285633"/>
            <a:ext cx="2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7A9D2A-7310-403E-B693-5E9BA7224197}"/>
              </a:ext>
            </a:extLst>
          </p:cNvPr>
          <p:cNvSpPr txBox="1"/>
          <p:nvPr/>
        </p:nvSpPr>
        <p:spPr>
          <a:xfrm>
            <a:off x="1993856" y="3166383"/>
            <a:ext cx="2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4FD8C51-C074-4514-9E91-AFAB7FFDA1A6}"/>
              </a:ext>
            </a:extLst>
          </p:cNvPr>
          <p:cNvSpPr txBox="1"/>
          <p:nvPr/>
        </p:nvSpPr>
        <p:spPr>
          <a:xfrm>
            <a:off x="5401973" y="3166383"/>
            <a:ext cx="2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92770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9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GraphPad Prism 9 Projec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ett, Andrean L</dc:creator>
  <cp:lastModifiedBy>Burnett, Andrean L</cp:lastModifiedBy>
  <cp:revision>2</cp:revision>
  <dcterms:created xsi:type="dcterms:W3CDTF">2022-10-21T21:22:25Z</dcterms:created>
  <dcterms:modified xsi:type="dcterms:W3CDTF">2022-10-22T00:32:29Z</dcterms:modified>
</cp:coreProperties>
</file>